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3288" y="4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0376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407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028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4961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1552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3812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8784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3711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4408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059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2173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EFFD57-1443-4DE3-AB4C-80EDB60CD027}" type="datetimeFigureOut">
              <a:rPr lang="en-GB" smtClean="0"/>
              <a:t>30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F409D-F4AC-4B7B-8324-61A8597F23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688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-45797" y="399646"/>
            <a:ext cx="4232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. 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028261" y="399645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.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277508" y="3770754"/>
            <a:ext cx="1667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LPS               -            -          +           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A94E82-73DB-4C29-AC83-DB6F61A79741}"/>
              </a:ext>
            </a:extLst>
          </p:cNvPr>
          <p:cNvSpPr txBox="1"/>
          <p:nvPr/>
        </p:nvSpPr>
        <p:spPr>
          <a:xfrm>
            <a:off x="208728" y="3880314"/>
            <a:ext cx="1845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Nigericin        -           +           -           +</a:t>
            </a:r>
          </a:p>
          <a:p>
            <a:endParaRPr lang="en-GB" sz="800" b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45187" y="1039857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IL-1</a:t>
            </a:r>
            <a:r>
              <a:rPr lang="el-GR" sz="800" dirty="0"/>
              <a:t>β</a:t>
            </a:r>
            <a:r>
              <a:rPr lang="en-GB" sz="800" dirty="0"/>
              <a:t> (pg/ml)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-33307" y="2181656"/>
            <a:ext cx="7200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IL-18 (pg/ml)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-10983" y="3162945"/>
            <a:ext cx="6896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% cell death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91828" y="553533"/>
            <a:ext cx="1512168" cy="250221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2254555" y="2950953"/>
            <a:ext cx="188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LPS               -              -            +            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BA94E82-73DB-4C29-AC83-DB6F61A79741}"/>
              </a:ext>
            </a:extLst>
          </p:cNvPr>
          <p:cNvSpPr txBox="1"/>
          <p:nvPr/>
        </p:nvSpPr>
        <p:spPr>
          <a:xfrm>
            <a:off x="2190949" y="3068922"/>
            <a:ext cx="22409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Nigericin        -             +            -             +</a:t>
            </a:r>
          </a:p>
          <a:p>
            <a:endParaRPr lang="en-GB" sz="8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EC574A-C573-464C-8777-E71C909ADF71}"/>
              </a:ext>
            </a:extLst>
          </p:cNvPr>
          <p:cNvSpPr txBox="1"/>
          <p:nvPr/>
        </p:nvSpPr>
        <p:spPr>
          <a:xfrm>
            <a:off x="3941673" y="2488231"/>
            <a:ext cx="632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GSDMD FL</a:t>
            </a:r>
            <a:endParaRPr lang="en-GB" sz="800" i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EC574A-C573-464C-8777-E71C909ADF71}"/>
              </a:ext>
            </a:extLst>
          </p:cNvPr>
          <p:cNvSpPr txBox="1"/>
          <p:nvPr/>
        </p:nvSpPr>
        <p:spPr>
          <a:xfrm>
            <a:off x="3957294" y="2745836"/>
            <a:ext cx="7090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GSDMD NT</a:t>
            </a:r>
            <a:endParaRPr lang="en-GB" sz="800" i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5EFAD46-1766-4F30-8F81-B529470DF672}"/>
              </a:ext>
            </a:extLst>
          </p:cNvPr>
          <p:cNvSpPr txBox="1"/>
          <p:nvPr/>
        </p:nvSpPr>
        <p:spPr>
          <a:xfrm>
            <a:off x="3955422" y="760658"/>
            <a:ext cx="5926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mIL-18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89F023B-A929-4654-B19E-212204131CD6}"/>
              </a:ext>
            </a:extLst>
          </p:cNvPr>
          <p:cNvSpPr txBox="1"/>
          <p:nvPr/>
        </p:nvSpPr>
        <p:spPr>
          <a:xfrm>
            <a:off x="3951423" y="1752622"/>
            <a:ext cx="5926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mIL-37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4A1AB84-B62F-4418-BAD4-BC2DACB79479}"/>
              </a:ext>
            </a:extLst>
          </p:cNvPr>
          <p:cNvSpPr txBox="1"/>
          <p:nvPr/>
        </p:nvSpPr>
        <p:spPr>
          <a:xfrm>
            <a:off x="3943209" y="1458681"/>
            <a:ext cx="588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pro-IL-37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1D3512D-5890-4565-A74C-2E90EFA38751}"/>
              </a:ext>
            </a:extLst>
          </p:cNvPr>
          <p:cNvSpPr txBox="1"/>
          <p:nvPr/>
        </p:nvSpPr>
        <p:spPr>
          <a:xfrm>
            <a:off x="3955546" y="605972"/>
            <a:ext cx="7199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pro-IL-18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1D3512D-5890-4565-A74C-2E90EFA38751}"/>
              </a:ext>
            </a:extLst>
          </p:cNvPr>
          <p:cNvSpPr txBox="1"/>
          <p:nvPr/>
        </p:nvSpPr>
        <p:spPr>
          <a:xfrm>
            <a:off x="3958529" y="953456"/>
            <a:ext cx="7065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pro-IL-1</a:t>
            </a:r>
            <a:r>
              <a:rPr lang="el-GR" sz="800" dirty="0"/>
              <a:t>β</a:t>
            </a:r>
            <a:r>
              <a:rPr lang="en-GB" sz="800" dirty="0"/>
              <a:t>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EFAD46-1766-4F30-8F81-B529470DF672}"/>
              </a:ext>
            </a:extLst>
          </p:cNvPr>
          <p:cNvSpPr txBox="1"/>
          <p:nvPr/>
        </p:nvSpPr>
        <p:spPr>
          <a:xfrm>
            <a:off x="3953617" y="1263160"/>
            <a:ext cx="6479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mIL-1</a:t>
            </a:r>
            <a:r>
              <a:rPr lang="el-GR" sz="800" dirty="0"/>
              <a:t>β</a:t>
            </a:r>
            <a:r>
              <a:rPr lang="en-GB" sz="800" dirty="0"/>
              <a:t>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054DA3A-677F-4958-A5E3-AF361DA127F9}"/>
              </a:ext>
            </a:extLst>
          </p:cNvPr>
          <p:cNvSpPr txBox="1"/>
          <p:nvPr/>
        </p:nvSpPr>
        <p:spPr>
          <a:xfrm>
            <a:off x="3943209" y="1991466"/>
            <a:ext cx="6863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Casp-1 p45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89F023B-A929-4654-B19E-212204131CD6}"/>
              </a:ext>
            </a:extLst>
          </p:cNvPr>
          <p:cNvSpPr txBox="1"/>
          <p:nvPr/>
        </p:nvSpPr>
        <p:spPr>
          <a:xfrm>
            <a:off x="3941673" y="2331851"/>
            <a:ext cx="7102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Casp-1 p20  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2479129" y="605780"/>
            <a:ext cx="0" cy="2345173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189F023B-A929-4654-B19E-212204131CD6}"/>
              </a:ext>
            </a:extLst>
          </p:cNvPr>
          <p:cNvSpPr txBox="1"/>
          <p:nvPr/>
        </p:nvSpPr>
        <p:spPr>
          <a:xfrm rot="16200000">
            <a:off x="1493481" y="1131361"/>
            <a:ext cx="1815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/>
              <a:t>Supernatant  </a:t>
            </a:r>
          </a:p>
        </p:txBody>
      </p:sp>
      <p:cxnSp>
        <p:nvCxnSpPr>
          <p:cNvPr id="28" name="Straight Connector 27"/>
          <p:cNvCxnSpPr/>
          <p:nvPr/>
        </p:nvCxnSpPr>
        <p:spPr>
          <a:xfrm flipH="1">
            <a:off x="4757038" y="655261"/>
            <a:ext cx="4363" cy="3229819"/>
          </a:xfrm>
          <a:prstGeom prst="line">
            <a:avLst/>
          </a:prstGeom>
          <a:ln w="95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89F023B-A929-4654-B19E-212204131CD6}"/>
              </a:ext>
            </a:extLst>
          </p:cNvPr>
          <p:cNvSpPr txBox="1"/>
          <p:nvPr/>
        </p:nvSpPr>
        <p:spPr>
          <a:xfrm rot="16200000">
            <a:off x="3768038" y="1813302"/>
            <a:ext cx="18155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/>
            <a:r>
              <a:rPr lang="en-GB" sz="900" b="1" dirty="0"/>
              <a:t>Lysat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1D3512D-5890-4565-A74C-2E90EFA38751}"/>
              </a:ext>
            </a:extLst>
          </p:cNvPr>
          <p:cNvSpPr txBox="1"/>
          <p:nvPr/>
        </p:nvSpPr>
        <p:spPr>
          <a:xfrm>
            <a:off x="6197355" y="598855"/>
            <a:ext cx="1073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pro-IL-18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054DA3A-677F-4958-A5E3-AF361DA127F9}"/>
              </a:ext>
            </a:extLst>
          </p:cNvPr>
          <p:cNvSpPr txBox="1"/>
          <p:nvPr/>
        </p:nvSpPr>
        <p:spPr>
          <a:xfrm>
            <a:off x="6186727" y="1954449"/>
            <a:ext cx="243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Casp-1 p45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618C6C9-8F82-4468-8F55-4AA5B6A1A5DF}"/>
              </a:ext>
            </a:extLst>
          </p:cNvPr>
          <p:cNvSpPr txBox="1"/>
          <p:nvPr/>
        </p:nvSpPr>
        <p:spPr>
          <a:xfrm>
            <a:off x="6186727" y="3690290"/>
            <a:ext cx="243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/>
              <a:t>β</a:t>
            </a:r>
            <a:r>
              <a:rPr lang="en-GB" sz="800" dirty="0"/>
              <a:t>-actin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054DA3A-677F-4958-A5E3-AF361DA127F9}"/>
              </a:ext>
            </a:extLst>
          </p:cNvPr>
          <p:cNvSpPr txBox="1"/>
          <p:nvPr/>
        </p:nvSpPr>
        <p:spPr>
          <a:xfrm>
            <a:off x="6186727" y="3122816"/>
            <a:ext cx="243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UBE2L3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89F023B-A929-4654-B19E-212204131CD6}"/>
              </a:ext>
            </a:extLst>
          </p:cNvPr>
          <p:cNvSpPr txBox="1"/>
          <p:nvPr/>
        </p:nvSpPr>
        <p:spPr>
          <a:xfrm>
            <a:off x="6197354" y="1760142"/>
            <a:ext cx="1815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mIL-37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4A1AB84-B62F-4418-BAD4-BC2DACB79479}"/>
              </a:ext>
            </a:extLst>
          </p:cNvPr>
          <p:cNvSpPr txBox="1"/>
          <p:nvPr/>
        </p:nvSpPr>
        <p:spPr>
          <a:xfrm>
            <a:off x="6197354" y="1511191"/>
            <a:ext cx="243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pro-IL-37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7EC574A-C573-464C-8777-E71C909ADF71}"/>
              </a:ext>
            </a:extLst>
          </p:cNvPr>
          <p:cNvSpPr txBox="1"/>
          <p:nvPr/>
        </p:nvSpPr>
        <p:spPr>
          <a:xfrm>
            <a:off x="6186727" y="2512848"/>
            <a:ext cx="3268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GSDMD FL</a:t>
            </a:r>
            <a:endParaRPr lang="en-GB" sz="800" i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5EFAD46-1766-4F30-8F81-B529470DF672}"/>
              </a:ext>
            </a:extLst>
          </p:cNvPr>
          <p:cNvSpPr txBox="1"/>
          <p:nvPr/>
        </p:nvSpPr>
        <p:spPr>
          <a:xfrm>
            <a:off x="6197355" y="814532"/>
            <a:ext cx="1073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mIL-18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1D3512D-5890-4565-A74C-2E90EFA38751}"/>
              </a:ext>
            </a:extLst>
          </p:cNvPr>
          <p:cNvSpPr txBox="1"/>
          <p:nvPr/>
        </p:nvSpPr>
        <p:spPr>
          <a:xfrm>
            <a:off x="6190815" y="1014855"/>
            <a:ext cx="14145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pro-IL-1</a:t>
            </a:r>
            <a:r>
              <a:rPr lang="el-GR" sz="800" dirty="0"/>
              <a:t>β</a:t>
            </a:r>
            <a:r>
              <a:rPr lang="en-GB" sz="800" dirty="0"/>
              <a:t>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5EFAD46-1766-4F30-8F81-B529470DF672}"/>
              </a:ext>
            </a:extLst>
          </p:cNvPr>
          <p:cNvSpPr txBox="1"/>
          <p:nvPr/>
        </p:nvSpPr>
        <p:spPr>
          <a:xfrm>
            <a:off x="6197354" y="1323133"/>
            <a:ext cx="1073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mIL-1</a:t>
            </a:r>
            <a:r>
              <a:rPr lang="el-GR" sz="800" dirty="0"/>
              <a:t>β</a:t>
            </a:r>
            <a:r>
              <a:rPr lang="en-GB" sz="800" dirty="0"/>
              <a:t> 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89F023B-A929-4654-B19E-212204131CD6}"/>
              </a:ext>
            </a:extLst>
          </p:cNvPr>
          <p:cNvSpPr txBox="1"/>
          <p:nvPr/>
        </p:nvSpPr>
        <p:spPr>
          <a:xfrm>
            <a:off x="6186727" y="2307731"/>
            <a:ext cx="18155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Casp-1 p20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7EC574A-C573-464C-8777-E71C909ADF71}"/>
              </a:ext>
            </a:extLst>
          </p:cNvPr>
          <p:cNvSpPr txBox="1"/>
          <p:nvPr/>
        </p:nvSpPr>
        <p:spPr>
          <a:xfrm>
            <a:off x="6186727" y="2873096"/>
            <a:ext cx="3268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GSDMD NT</a:t>
            </a:r>
            <a:endParaRPr lang="en-GB" sz="800" i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618C6C9-8F82-4468-8F55-4AA5B6A1A5DF}"/>
              </a:ext>
            </a:extLst>
          </p:cNvPr>
          <p:cNvSpPr txBox="1"/>
          <p:nvPr/>
        </p:nvSpPr>
        <p:spPr>
          <a:xfrm>
            <a:off x="6197354" y="3466527"/>
            <a:ext cx="2438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NLRP3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4482174" y="3885080"/>
            <a:ext cx="18820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LPS                 -             -            +           +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BA94E82-73DB-4C29-AC83-DB6F61A79741}"/>
              </a:ext>
            </a:extLst>
          </p:cNvPr>
          <p:cNvSpPr txBox="1"/>
          <p:nvPr/>
        </p:nvSpPr>
        <p:spPr>
          <a:xfrm>
            <a:off x="4418568" y="4003049"/>
            <a:ext cx="22409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Nigericin          -            +            -            +</a:t>
            </a:r>
          </a:p>
          <a:p>
            <a:endParaRPr lang="en-GB" sz="8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49751" y="611560"/>
            <a:ext cx="1495049" cy="334283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/>
          <a:srcRect l="68535" t="55" r="1182" b="4888"/>
          <a:stretch/>
        </p:blipFill>
        <p:spPr>
          <a:xfrm>
            <a:off x="448269" y="528370"/>
            <a:ext cx="1530463" cy="3340917"/>
          </a:xfrm>
          <a:prstGeom prst="rect">
            <a:avLst/>
          </a:prstGeom>
        </p:spPr>
      </p:pic>
      <p:cxnSp>
        <p:nvCxnSpPr>
          <p:cNvPr id="45" name="Straight Connector 44"/>
          <p:cNvCxnSpPr/>
          <p:nvPr/>
        </p:nvCxnSpPr>
        <p:spPr>
          <a:xfrm>
            <a:off x="1484784" y="821416"/>
            <a:ext cx="2686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1188301" y="719883"/>
            <a:ext cx="5650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862191" y="1170827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/>
              <a:t>ns</a:t>
            </a:r>
            <a:endParaRPr lang="en-GB" sz="700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862655" y="1352604"/>
            <a:ext cx="2686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1302767" y="588746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/>
              <a:t>***</a:t>
            </a:r>
            <a:endParaRPr lang="en-GB" sz="700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1468294" y="690419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/>
              <a:t>***</a:t>
            </a:r>
            <a:endParaRPr lang="en-GB" sz="700" b="1" dirty="0"/>
          </a:p>
        </p:txBody>
      </p:sp>
      <p:cxnSp>
        <p:nvCxnSpPr>
          <p:cNvPr id="51" name="Straight Connector 50"/>
          <p:cNvCxnSpPr/>
          <p:nvPr/>
        </p:nvCxnSpPr>
        <p:spPr>
          <a:xfrm>
            <a:off x="1468294" y="1927651"/>
            <a:ext cx="2686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862655" y="2147512"/>
            <a:ext cx="2686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1171811" y="1848109"/>
            <a:ext cx="5650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871777" y="1993786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/>
              <a:t>ns</a:t>
            </a:r>
            <a:endParaRPr lang="en-GB" sz="7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1313583" y="1716090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/>
              <a:t>**</a:t>
            </a:r>
            <a:endParaRPr lang="en-GB" sz="7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1477861" y="1807452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 smtClean="0"/>
              <a:t>**</a:t>
            </a:r>
            <a:endParaRPr lang="en-GB" sz="700" b="1" dirty="0"/>
          </a:p>
        </p:txBody>
      </p:sp>
      <p:cxnSp>
        <p:nvCxnSpPr>
          <p:cNvPr id="57" name="Straight Connector 56"/>
          <p:cNvCxnSpPr/>
          <p:nvPr/>
        </p:nvCxnSpPr>
        <p:spPr>
          <a:xfrm>
            <a:off x="900988" y="3338260"/>
            <a:ext cx="2686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1015055" y="1505004"/>
            <a:ext cx="2686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1454357" y="3283021"/>
            <a:ext cx="26860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1155711" y="3166397"/>
            <a:ext cx="5650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917180" y="3194759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/>
              <a:t>ns</a:t>
            </a:r>
            <a:endParaRPr lang="en-GB" sz="7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1310424" y="3005325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/>
              <a:t>ns</a:t>
            </a:r>
            <a:endParaRPr lang="en-GB" sz="7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CDF2B71-AE74-44D0-BF55-E4B7EF145998}"/>
              </a:ext>
            </a:extLst>
          </p:cNvPr>
          <p:cNvSpPr txBox="1"/>
          <p:nvPr/>
        </p:nvSpPr>
        <p:spPr>
          <a:xfrm>
            <a:off x="1458478" y="3130510"/>
            <a:ext cx="4858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 smtClean="0"/>
              <a:t>ns</a:t>
            </a:r>
            <a:endParaRPr lang="en-GB" sz="700" dirty="0"/>
          </a:p>
        </p:txBody>
      </p:sp>
      <p:sp>
        <p:nvSpPr>
          <p:cNvPr id="4" name="TextBox 3"/>
          <p:cNvSpPr txBox="1"/>
          <p:nvPr/>
        </p:nvSpPr>
        <p:spPr>
          <a:xfrm>
            <a:off x="668063" y="4234966"/>
            <a:ext cx="5696120" cy="186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/>
              <a:t> </a:t>
            </a:r>
            <a:endParaRPr lang="en-GB" sz="1050" dirty="0"/>
          </a:p>
          <a:p>
            <a:r>
              <a:rPr lang="en-GB" sz="1050" b="1" dirty="0"/>
              <a:t>Figure 2S: Priming greatly potentiates NLRP3 inflammasome activation in human macrophages</a:t>
            </a:r>
            <a:r>
              <a:rPr lang="en-GB" sz="1050" dirty="0"/>
              <a:t>. MDMs were left untreated or primed with LPS (1 µg/mL, 4h) prior to treatment with nigericin (10 µM, 45min) to activate NLRP3 inflammasome. (A) IL-1β and IL-18 were measured by ELISA and cell death was measured by LDH assay and shown as percentage relative to total cell death, n=6. ** = P &lt; 0.01; *** = P &lt;0.001. (B) Western blot analysis of MDMs for mIL-18 (18 kDa), pro-IL-18 (24 kDa), mIL-1β (17 kDa), pro-IL-1β (31 kDa), mIL-37 (17.5 kDa), pro-IL-37 (26 kDa), mCaspase-1 (20 kDa), pro-Caspase-1 (45 kDa), GSDMD full length (FL, 53 kDa), GSDMD N-terminus (NT, 31 kDa), UBE2L3 (17.9 kDa), NLRP3 (113 kDa), as well as loading control β-actin (42 kDa). Blots are representative of at least 3 independent experiments.</a:t>
            </a:r>
          </a:p>
          <a:p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2813949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3</Words>
  <Application>Microsoft Office PowerPoint</Application>
  <PresentationFormat>On-screen Show (4:3)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loria Lopez-castejon</dc:creator>
  <cp:lastModifiedBy>Anna Gritsenko</cp:lastModifiedBy>
  <cp:revision>2</cp:revision>
  <dcterms:created xsi:type="dcterms:W3CDTF">2020-01-29T16:50:59Z</dcterms:created>
  <dcterms:modified xsi:type="dcterms:W3CDTF">2020-01-30T09:14:15Z</dcterms:modified>
</cp:coreProperties>
</file>